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  <p:sldId id="272" r:id="rId3"/>
    <p:sldId id="273" r:id="rId4"/>
    <p:sldId id="270" r:id="rId5"/>
    <p:sldId id="271" r:id="rId6"/>
  </p:sldIdLst>
  <p:sldSz cx="6858000" cy="9906000" type="A4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481" userDrawn="1">
          <p15:clr>
            <a:srgbClr val="A4A3A4"/>
          </p15:clr>
        </p15:guide>
        <p15:guide id="2" pos="345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2616" y="-570"/>
      </p:cViewPr>
      <p:guideLst>
        <p:guide orient="horz" pos="4481"/>
        <p:guide pos="345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5644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0671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0992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0888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6594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2216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30143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4158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3510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2005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729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58E86C-E32D-4F2C-A64C-EB609FEA050F}" type="datetimeFigureOut">
              <a:rPr lang="ko-KR" altLang="en-US" smtClean="0"/>
              <a:t>2024-04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97FE0-FB40-4CDB-BF6C-E63F77BEC4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7850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mp"/><Relationship Id="rId2" Type="http://schemas.openxmlformats.org/officeDocument/2006/relationships/image" Target="../media/image7.tmp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34390" y="303910"/>
            <a:ext cx="2578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6388" y="1044126"/>
            <a:ext cx="6083843" cy="36000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285977"/>
            <a:ext cx="6858000" cy="407448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818147"/>
            <a:ext cx="2832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A</a:t>
            </a:r>
            <a:endParaRPr lang="ko-KR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0048" y="5037223"/>
            <a:ext cx="2832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B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348150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그림 2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4433"/>
            <a:ext cx="6858000" cy="4074487"/>
          </a:xfrm>
          <a:prstGeom prst="rect">
            <a:avLst/>
          </a:prstGeom>
        </p:spPr>
      </p:pic>
      <p:pic>
        <p:nvPicPr>
          <p:cNvPr id="29" name="그림 2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278920"/>
            <a:ext cx="6858000" cy="41368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14705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3499"/>
            <a:ext cx="6858000" cy="414167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180474" y="4682632"/>
            <a:ext cx="5847347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>
              <a:lnSpc>
                <a:spcPct val="200000"/>
              </a:lnSpc>
            </a:pPr>
            <a:r>
              <a:rPr lang="en-US" altLang="ko-KR" sz="1200" b="1" kern="24000" dirty="0">
                <a:ln w="12700">
                  <a:prstDash val="solid"/>
                  <a:round/>
                </a:ln>
                <a:solidFill>
                  <a:srgbClr val="000000"/>
                </a:solidFill>
                <a:latin typeface="Times New Roman" panose="02020603050405020304" pitchFamily="18" charset="0"/>
              </a:rPr>
              <a:t>Supplementary Figure 1.</a:t>
            </a:r>
            <a:r>
              <a:rPr lang="en-US" altLang="ko-KR" sz="1200" dirty="0"/>
              <a:t> </a:t>
            </a:r>
            <a:r>
              <a:rPr lang="en-US" altLang="ko-KR" sz="1200" b="1" kern="24000" dirty="0">
                <a:ln w="12700">
                  <a:prstDash val="solid"/>
                  <a:round/>
                </a:ln>
                <a:solidFill>
                  <a:srgbClr val="000000"/>
                </a:solidFill>
                <a:latin typeface="Times New Roman" panose="02020603050405020304" pitchFamily="18" charset="0"/>
              </a:rPr>
              <a:t>Detailed Information on ROI Labeling in DSP Analysis</a:t>
            </a:r>
            <a:r>
              <a:rPr lang="en-US" altLang="ko-KR" sz="1200" kern="24000" dirty="0">
                <a:ln w="12700">
                  <a:prstDash val="solid"/>
                  <a:round/>
                </a:ln>
                <a:solidFill>
                  <a:srgbClr val="000000"/>
                </a:solidFill>
                <a:latin typeface="Times New Roman" panose="02020603050405020304" pitchFamily="18" charset="0"/>
              </a:rPr>
              <a:t>. This figure presents the analysis of 48 Regions of Interest (ROIs). Among these, 36 CK-positive ROIs were selected to study tumorigenesis, which included 28 ROIs of SNUC carcinoma cells and 8 ROIs of normal epithelial cells surrounding the tumor. In addition, 10 ROIs were chosen to investigate tumor immunity within CD45-positive regions, comprising 7 ROIs of tumor-infiltrating immune cells and 3 ROIs of immune cells in tumor-free areas. </a:t>
            </a:r>
            <a:endParaRPr lang="en-US" altLang="ko-KR" sz="1200" dirty="0"/>
          </a:p>
          <a:p>
            <a:pPr fontAlgn="base">
              <a:lnSpc>
                <a:spcPct val="200000"/>
              </a:lnSpc>
            </a:pPr>
            <a:r>
              <a:rPr lang="en-US" altLang="ko-KR" sz="1200" kern="24000" dirty="0">
                <a:ln w="12700">
                  <a:prstDash val="solid"/>
                  <a:round/>
                </a:ln>
                <a:solidFill>
                  <a:srgbClr val="000000"/>
                </a:solidFill>
                <a:latin typeface="Times New Roman" panose="02020603050405020304" pitchFamily="18" charset="0"/>
              </a:rPr>
              <a:t>Subsequently, the patient cohort was divided into groups based on their median disease-free survival to assess prognosis (A and B). These groups were further categorized into metastasis and non-metastasis groups according to the presence of metastasis. In the ongoing study, no significant differences were found between the metastasis and non-metastasis groups (B). </a:t>
            </a:r>
            <a:endParaRPr lang="en-US" altLang="ko-KR" sz="1200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6095518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34390" y="303910"/>
            <a:ext cx="2578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그림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32599"/>
            <a:ext cx="6447909" cy="4785363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317269" y="5898813"/>
            <a:ext cx="5979027" cy="11440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Immunofluorescence Images of CD45-Positive Immune Cell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is figure features two sets of images: (A) displays CD45-positive immune cells within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ratumor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gions of Interest (ROIs), and (B) shows these cells in tumor-free area ROIs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4717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/>
          <p:cNvGrpSpPr/>
          <p:nvPr/>
        </p:nvGrpSpPr>
        <p:grpSpPr>
          <a:xfrm>
            <a:off x="79901" y="660241"/>
            <a:ext cx="6480000" cy="8111135"/>
            <a:chOff x="79901" y="660241"/>
            <a:chExt cx="6480000" cy="8111135"/>
          </a:xfrm>
        </p:grpSpPr>
        <p:pic>
          <p:nvPicPr>
            <p:cNvPr id="2" name="그림 1" descr="화면 캡처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901" y="660241"/>
              <a:ext cx="6480000" cy="4058483"/>
            </a:xfrm>
            <a:prstGeom prst="rect">
              <a:avLst/>
            </a:prstGeom>
          </p:spPr>
        </p:pic>
        <p:pic>
          <p:nvPicPr>
            <p:cNvPr id="3" name="그림 2" descr="화면 캡처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901" y="4718724"/>
              <a:ext cx="6480000" cy="4052652"/>
            </a:xfrm>
            <a:prstGeom prst="rect">
              <a:avLst/>
            </a:prstGeom>
          </p:spPr>
        </p:pic>
      </p:grpSp>
      <p:sp>
        <p:nvSpPr>
          <p:cNvPr id="4" name="직사각형 3"/>
          <p:cNvSpPr/>
          <p:nvPr/>
        </p:nvSpPr>
        <p:spPr>
          <a:xfrm>
            <a:off x="205739" y="8847632"/>
            <a:ext cx="600565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Wilcoxon-signed rank test images of gene expression status regarding tumor immunity</a:t>
            </a:r>
          </a:p>
        </p:txBody>
      </p:sp>
      <p:sp>
        <p:nvSpPr>
          <p:cNvPr id="5" name="직사각형 4"/>
          <p:cNvSpPr/>
          <p:nvPr/>
        </p:nvSpPr>
        <p:spPr>
          <a:xfrm>
            <a:off x="79901" y="191560"/>
            <a:ext cx="26362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 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3500478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3</TotalTime>
  <Words>220</Words>
  <Application>Microsoft Office PowerPoint</Application>
  <PresentationFormat>A4 용지(210x297mm)</PresentationFormat>
  <Paragraphs>9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세희(병리과)</dc:creator>
  <cp:lastModifiedBy> </cp:lastModifiedBy>
  <cp:revision>71</cp:revision>
  <cp:lastPrinted>2023-02-07T12:40:05Z</cp:lastPrinted>
  <dcterms:created xsi:type="dcterms:W3CDTF">2023-02-05T11:12:23Z</dcterms:created>
  <dcterms:modified xsi:type="dcterms:W3CDTF">2024-04-23T04:07:49Z</dcterms:modified>
</cp:coreProperties>
</file>